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19D8EB-4905-C853-9F75-E9C2D4BBCD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65F1EE0-754B-5A74-58A5-21DE972ACD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3B6E2A-4240-6BA2-1ED6-CE676B35F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C07D6C-4CA6-AA5D-C21D-A1D825BBC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182EB1-CAC9-FF0A-EF5A-C30E3795D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48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1BA219-7FA9-94FF-B02E-7734DE641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760834-6753-D344-7B69-D5B098A6DA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26A5B3-80E8-F3A0-0E87-31BA62F98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5E87B8-179F-4EC6-952E-AFEFD957A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DCFCD5-DE6C-8F87-FA15-E284E9A92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0233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8C70CE2-AC66-9B71-0F15-D7B766781F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EAF3D2-9DDB-8B20-497C-27E432A625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885534-C5F3-6357-F1AE-E150A473F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5DB135-DE1E-974B-459A-15C719BE5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6131DC-A9D4-D46B-795C-3049A7CF9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8186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DF411D-72E0-7639-DD83-0DCD640C8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C34588-D5D1-AF9C-7D82-5ABE3B2E53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5DDF13-D51A-FD5E-E4CA-C5A96BD1B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ACEA86-9DE5-E595-1369-0218E490E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81867A-D931-67D6-5A72-2BE948BA0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496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DEAB71-656E-561C-7A0E-CBD6A7699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B0BB09-2D13-7A18-96D6-758BE02859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B30AE8-216E-42A3-009B-7992455E0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E3C1FD-CD93-5BA4-BCFD-74EE58AEC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231813-E2FD-B07B-2882-953530D94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420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5459AC-F769-4D63-C2C3-95BD55367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770B27-D90B-F536-B5F1-5F06B51CAA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71AF9AA-BAFD-36EB-9C27-DDF7E01767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035C33-10C5-757C-F68B-77E00BBD6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FF4BF3-53B8-6C47-66C3-B40E86B88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5D4707-0ABF-AD73-2F2D-4799CBE8A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999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40775C-4D67-E4E6-4D00-F0094CB16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E0C2F0-A864-AAC5-6E6F-B2B88CA496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3EDC991-3C33-DB59-E01D-D9C194B02F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55BAA3E-133D-F1EE-4C60-4E4B357EF0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875E6AF-82EE-1132-2E17-200C2D16AC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48FE6DC-8983-E519-B9BF-9B445D390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B3E900-472E-D6B0-36F7-1D24EB41F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7C33CC6-BD47-2972-0B63-9DB065DC7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513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EC656D-FBD1-E4B2-B4FA-20F9C872C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AE593FE-F2A8-08F4-BC24-BA2F9FA03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89703AF-0160-F6E8-80E2-E1E044475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47E0E78-11B2-47E9-C7A5-A07BA8640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372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4E4E04A-25E2-2D4C-C1C9-FB9B2EF17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F8A6A51-CFDB-D19D-3A49-BDB2F088A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BB4E84A-477B-659B-78F4-AB3FB2542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4975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3B1CCD-2F44-B0EC-0DC6-FBD0A6C95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7D9F659-0432-8265-DFE0-7E58A1092D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EE26C04-7607-8C59-2E6F-115716F912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FA863B7-13A4-1021-DC49-61B37290E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414FD6-514A-77F4-8356-37E535A4A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ED57E0D-6B2F-0A53-2E67-772AE6144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912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918C37-5675-1995-B87D-C8089917D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A64F47E-BAE5-E958-4C54-190C833EE1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4190EE5-85E6-BE86-F7B4-1EB46322D2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D35890-D114-E7CC-75CC-D35C4F01D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6DB929-0FDC-BB6E-0017-C71FFFD15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9799D44-6149-5D71-18A2-D5851C69C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8727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0E716EF-270F-0C74-A4C3-B718A3AD0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5C53C8-9DFE-9946-E831-48718525B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F34296-59CB-4312-B5BD-B2926CA5E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DFF0A-2AED-4933-97D6-3453151B6871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1967C9-2C01-6642-8678-74A9EBC13C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0EEAA2-1970-8C69-96F3-C5C521866E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2E2F8-12AF-4B39-8D69-06539099F5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31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5" Type="http://schemas.openxmlformats.org/officeDocument/2006/relationships/tags" Target="../tags/tag5.xml"/><Relationship Id="rId15" Type="http://schemas.openxmlformats.org/officeDocument/2006/relationships/image" Target="../media/image1.png"/><Relationship Id="rId10" Type="http://schemas.openxmlformats.org/officeDocument/2006/relationships/tags" Target="../tags/tag10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 descr="b13144d70682f8a09d77be45e552812">
            <a:extLst>
              <a:ext uri="{FF2B5EF4-FFF2-40B4-BE49-F238E27FC236}">
                <a16:creationId xmlns:a16="http://schemas.microsoft.com/office/drawing/2014/main" id="{E369F5F5-8812-B467-D1FA-0AF751A79733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2848507" y="1650575"/>
            <a:ext cx="6494985" cy="280592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2718D265-6FE4-4238-2533-0CE16CB3865A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2345254" y="2709103"/>
            <a:ext cx="608472" cy="1015663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000bp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00bp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750bp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500bp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50bp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0bp</a:t>
            </a: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88005AFA-5AED-1E65-425D-E7873A348DFD}"/>
              </a:ext>
            </a:extLst>
          </p:cNvPr>
          <p:cNvCxnSpPr/>
          <p:nvPr>
            <p:custDataLst>
              <p:tags r:id="rId3"/>
            </p:custDataLst>
          </p:nvPr>
        </p:nvCxnSpPr>
        <p:spPr>
          <a:xfrm flipH="1">
            <a:off x="9325548" y="3030706"/>
            <a:ext cx="482862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BC39FCF3-BFCA-4756-10BF-8D2D2EC4B5A4}"/>
              </a:ext>
            </a:extLst>
          </p:cNvPr>
          <p:cNvCxnSpPr/>
          <p:nvPr>
            <p:custDataLst>
              <p:tags r:id="rId4"/>
            </p:custDataLst>
          </p:nvPr>
        </p:nvCxnSpPr>
        <p:spPr>
          <a:xfrm flipH="1">
            <a:off x="9317392" y="3258192"/>
            <a:ext cx="482862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3432406C-3BCD-FD60-3FCC-66C9E46FD268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 flipH="1">
            <a:off x="9317392" y="3411985"/>
            <a:ext cx="482862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BAEEFAC4-CD91-75FD-2B87-8080AD0E2A97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9800254" y="2907352"/>
            <a:ext cx="151791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115bp</a:t>
            </a:r>
          </a:p>
          <a:p>
            <a:r>
              <a:rPr lang="en-US" altLang="zh-CN" sz="1000" b="1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00bp</a:t>
            </a:r>
          </a:p>
          <a:p>
            <a:r>
              <a:rPr lang="en-US" altLang="zh-CN" sz="1000" b="1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400bp</a:t>
            </a: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E2DDDD01-EFA0-235D-8720-2EFA9E2C7816}"/>
              </a:ext>
            </a:extLst>
          </p:cNvPr>
          <p:cNvCxnSpPr/>
          <p:nvPr>
            <p:custDataLst>
              <p:tags r:id="rId7"/>
            </p:custDataLst>
          </p:nvPr>
        </p:nvCxnSpPr>
        <p:spPr>
          <a:xfrm>
            <a:off x="3894165" y="1664193"/>
            <a:ext cx="25285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C390819D-C581-5CDF-1429-52CF5F1FB613}"/>
              </a:ext>
            </a:extLst>
          </p:cNvPr>
          <p:cNvCxnSpPr/>
          <p:nvPr>
            <p:custDataLst>
              <p:tags r:id="rId8"/>
            </p:custDataLst>
          </p:nvPr>
        </p:nvCxnSpPr>
        <p:spPr>
          <a:xfrm>
            <a:off x="8471567" y="1664193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2E99318-5CF0-564C-F7BE-DD9808D19BA7}"/>
              </a:ext>
            </a:extLst>
          </p:cNvPr>
          <p:cNvCxnSpPr/>
          <p:nvPr>
            <p:custDataLst>
              <p:tags r:id="rId9"/>
            </p:custDataLst>
          </p:nvPr>
        </p:nvCxnSpPr>
        <p:spPr>
          <a:xfrm>
            <a:off x="7697520" y="1672203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9DC748A0-47A0-A734-3205-D8D73EAE3061}"/>
              </a:ext>
            </a:extLst>
          </p:cNvPr>
          <p:cNvCxnSpPr/>
          <p:nvPr>
            <p:custDataLst>
              <p:tags r:id="rId10"/>
            </p:custDataLst>
          </p:nvPr>
        </p:nvCxnSpPr>
        <p:spPr>
          <a:xfrm>
            <a:off x="6909606" y="1650575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2788D7DA-7EEC-12A0-BCFF-CEEC694F24E7}"/>
              </a:ext>
            </a:extLst>
          </p:cNvPr>
          <p:cNvCxnSpPr/>
          <p:nvPr>
            <p:custDataLst>
              <p:tags r:id="rId11"/>
            </p:custDataLst>
          </p:nvPr>
        </p:nvCxnSpPr>
        <p:spPr>
          <a:xfrm>
            <a:off x="6167369" y="1672203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67386212-22B7-7028-0656-57CD645F8388}"/>
              </a:ext>
            </a:extLst>
          </p:cNvPr>
          <p:cNvCxnSpPr/>
          <p:nvPr>
            <p:custDataLst>
              <p:tags r:id="rId12"/>
            </p:custDataLst>
          </p:nvPr>
        </p:nvCxnSpPr>
        <p:spPr>
          <a:xfrm>
            <a:off x="5402293" y="1672203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AF2D15E-5CFB-1496-5BF6-9A4B666CCFE9}"/>
              </a:ext>
            </a:extLst>
          </p:cNvPr>
          <p:cNvCxnSpPr/>
          <p:nvPr>
            <p:custDataLst>
              <p:tags r:id="rId13"/>
            </p:custDataLst>
          </p:nvPr>
        </p:nvCxnSpPr>
        <p:spPr>
          <a:xfrm>
            <a:off x="4637218" y="1672203"/>
            <a:ext cx="13050" cy="27842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18B4696E-3286-9952-F964-112A99474AE0}"/>
              </a:ext>
            </a:extLst>
          </p:cNvPr>
          <p:cNvGrpSpPr/>
          <p:nvPr/>
        </p:nvGrpSpPr>
        <p:grpSpPr>
          <a:xfrm>
            <a:off x="2848507" y="1395204"/>
            <a:ext cx="6396369" cy="276999"/>
            <a:chOff x="2387667" y="1472206"/>
            <a:chExt cx="6396369" cy="276999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FFCA90B-2821-5612-A5F7-03D00364BC91}"/>
                </a:ext>
              </a:extLst>
            </p:cNvPr>
            <p:cNvSpPr txBox="1"/>
            <p:nvPr/>
          </p:nvSpPr>
          <p:spPr>
            <a:xfrm>
              <a:off x="2387667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M </a:t>
              </a:r>
              <a:endParaRPr lang="zh-CN" altLang="en-US" sz="1200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EC3C1D2-EA47-96BC-2E9B-1BB33709FCE6}"/>
                </a:ext>
              </a:extLst>
            </p:cNvPr>
            <p:cNvSpPr txBox="1"/>
            <p:nvPr/>
          </p:nvSpPr>
          <p:spPr>
            <a:xfrm>
              <a:off x="2640071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 </a:t>
              </a:r>
              <a:endParaRPr lang="zh-CN" altLang="en-US" sz="12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24DB9ACE-9CA5-165E-A7EF-5C063C1D3AB5}"/>
                </a:ext>
              </a:extLst>
            </p:cNvPr>
            <p:cNvSpPr txBox="1"/>
            <p:nvPr/>
          </p:nvSpPr>
          <p:spPr>
            <a:xfrm>
              <a:off x="2892475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 </a:t>
              </a:r>
              <a:endParaRPr lang="zh-CN" altLang="en-US" sz="12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D0DEFC5F-392D-6D68-AB77-AC4E57400243}"/>
                </a:ext>
              </a:extLst>
            </p:cNvPr>
            <p:cNvSpPr txBox="1"/>
            <p:nvPr/>
          </p:nvSpPr>
          <p:spPr>
            <a:xfrm>
              <a:off x="3144879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3 </a:t>
              </a:r>
              <a:endParaRPr lang="zh-CN" altLang="en-US" sz="1200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57570CE0-0030-698F-DAD7-4F55E80AC9EE}"/>
                </a:ext>
              </a:extLst>
            </p:cNvPr>
            <p:cNvSpPr txBox="1"/>
            <p:nvPr/>
          </p:nvSpPr>
          <p:spPr>
            <a:xfrm>
              <a:off x="3397283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4 </a:t>
              </a:r>
              <a:endParaRPr lang="zh-CN" altLang="en-US" sz="12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4DA1F00E-3F0A-EA80-26A9-B2924085859B}"/>
                </a:ext>
              </a:extLst>
            </p:cNvPr>
            <p:cNvSpPr txBox="1"/>
            <p:nvPr/>
          </p:nvSpPr>
          <p:spPr>
            <a:xfrm>
              <a:off x="3649687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5 </a:t>
              </a:r>
              <a:endParaRPr lang="zh-CN" altLang="en-US" sz="1200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B8CD4B5-18CF-03C8-88FC-8DB487B57DCC}"/>
                </a:ext>
              </a:extLst>
            </p:cNvPr>
            <p:cNvSpPr txBox="1"/>
            <p:nvPr/>
          </p:nvSpPr>
          <p:spPr>
            <a:xfrm>
              <a:off x="3902091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6 </a:t>
              </a:r>
              <a:endParaRPr lang="zh-CN" altLang="en-US" sz="1200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16ECF52B-6772-F494-AC50-694CE27FB40A}"/>
                </a:ext>
              </a:extLst>
            </p:cNvPr>
            <p:cNvSpPr txBox="1"/>
            <p:nvPr/>
          </p:nvSpPr>
          <p:spPr>
            <a:xfrm>
              <a:off x="4154495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endParaRPr lang="zh-CN" altLang="en-US" sz="1200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CB3E5512-9C9D-2A56-6491-74884C968043}"/>
                </a:ext>
              </a:extLst>
            </p:cNvPr>
            <p:cNvSpPr txBox="1"/>
            <p:nvPr/>
          </p:nvSpPr>
          <p:spPr>
            <a:xfrm>
              <a:off x="4406899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8 </a:t>
              </a:r>
              <a:endParaRPr lang="zh-CN" altLang="en-US" sz="1200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2C25720-5B7F-C223-3138-C26AB6E9DA03}"/>
                </a:ext>
              </a:extLst>
            </p:cNvPr>
            <p:cNvSpPr txBox="1"/>
            <p:nvPr/>
          </p:nvSpPr>
          <p:spPr>
            <a:xfrm>
              <a:off x="4659303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9 </a:t>
              </a:r>
              <a:endParaRPr lang="zh-CN" altLang="en-US" sz="12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6577B9FC-DD14-81B2-E031-B10958DF7C2A}"/>
                </a:ext>
              </a:extLst>
            </p:cNvPr>
            <p:cNvSpPr txBox="1"/>
            <p:nvPr/>
          </p:nvSpPr>
          <p:spPr>
            <a:xfrm>
              <a:off x="4911707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0 </a:t>
              </a:r>
              <a:endParaRPr lang="zh-CN" altLang="en-US" sz="12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AD7DE31-F0F1-F88E-A370-4416EBD938D2}"/>
                </a:ext>
              </a:extLst>
            </p:cNvPr>
            <p:cNvSpPr txBox="1"/>
            <p:nvPr/>
          </p:nvSpPr>
          <p:spPr>
            <a:xfrm>
              <a:off x="5164111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1 </a:t>
              </a:r>
              <a:endParaRPr lang="zh-CN" altLang="en-US" sz="12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8840096-FA42-8B10-35CE-DF61D3F23CE4}"/>
                </a:ext>
              </a:extLst>
            </p:cNvPr>
            <p:cNvSpPr txBox="1"/>
            <p:nvPr/>
          </p:nvSpPr>
          <p:spPr>
            <a:xfrm>
              <a:off x="5416515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2 </a:t>
              </a:r>
              <a:endParaRPr lang="zh-CN" altLang="en-US" sz="1200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F0AB5B89-E628-F603-3C7C-6220BA3FF5B7}"/>
                </a:ext>
              </a:extLst>
            </p:cNvPr>
            <p:cNvSpPr txBox="1"/>
            <p:nvPr/>
          </p:nvSpPr>
          <p:spPr>
            <a:xfrm>
              <a:off x="5668919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3 </a:t>
              </a:r>
              <a:endParaRPr lang="zh-CN" altLang="en-US" sz="1200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7FD64959-371A-FF25-5D53-F4FD024AE301}"/>
                </a:ext>
              </a:extLst>
            </p:cNvPr>
            <p:cNvSpPr txBox="1"/>
            <p:nvPr/>
          </p:nvSpPr>
          <p:spPr>
            <a:xfrm>
              <a:off x="5921323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4 </a:t>
              </a:r>
              <a:endParaRPr lang="zh-CN" altLang="en-US" sz="1200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D74D10B6-546F-6466-CFCD-5F4E3EBD6FDE}"/>
                </a:ext>
              </a:extLst>
            </p:cNvPr>
            <p:cNvSpPr txBox="1"/>
            <p:nvPr/>
          </p:nvSpPr>
          <p:spPr>
            <a:xfrm>
              <a:off x="6173727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5 </a:t>
              </a:r>
              <a:endParaRPr lang="zh-CN" altLang="en-US" sz="1200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B53A103-403B-5B7B-5B64-5FFABC721687}"/>
                </a:ext>
              </a:extLst>
            </p:cNvPr>
            <p:cNvSpPr txBox="1"/>
            <p:nvPr/>
          </p:nvSpPr>
          <p:spPr>
            <a:xfrm>
              <a:off x="6426131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6 </a:t>
              </a:r>
              <a:endParaRPr lang="zh-CN" altLang="en-US" sz="1200" dirty="0"/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21077A72-A103-1C1A-76B7-1644CBC12ADC}"/>
                </a:ext>
              </a:extLst>
            </p:cNvPr>
            <p:cNvSpPr txBox="1"/>
            <p:nvPr/>
          </p:nvSpPr>
          <p:spPr>
            <a:xfrm>
              <a:off x="6678535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7 </a:t>
              </a:r>
              <a:endParaRPr lang="zh-CN" altLang="en-US" sz="1200" dirty="0"/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B6233246-26DE-9137-EA87-D742DD4FF35D}"/>
                </a:ext>
              </a:extLst>
            </p:cNvPr>
            <p:cNvSpPr txBox="1"/>
            <p:nvPr/>
          </p:nvSpPr>
          <p:spPr>
            <a:xfrm>
              <a:off x="6930939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8 </a:t>
              </a:r>
              <a:endParaRPr lang="zh-CN" altLang="en-US" sz="1200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1977B4D-19CE-E37A-3930-E0B83EA87411}"/>
                </a:ext>
              </a:extLst>
            </p:cNvPr>
            <p:cNvSpPr txBox="1"/>
            <p:nvPr/>
          </p:nvSpPr>
          <p:spPr>
            <a:xfrm>
              <a:off x="7183343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19 </a:t>
              </a:r>
              <a:endParaRPr lang="zh-CN" altLang="en-US" sz="1200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B823CE1E-F80D-559F-BBC4-3E3C3B45DD7E}"/>
                </a:ext>
              </a:extLst>
            </p:cNvPr>
            <p:cNvSpPr txBox="1"/>
            <p:nvPr/>
          </p:nvSpPr>
          <p:spPr>
            <a:xfrm>
              <a:off x="7435747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0 </a:t>
              </a:r>
              <a:endParaRPr lang="zh-CN" altLang="en-US" sz="1200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FC2C2B2A-810A-DF96-6175-280B32474F86}"/>
                </a:ext>
              </a:extLst>
            </p:cNvPr>
            <p:cNvSpPr txBox="1"/>
            <p:nvPr/>
          </p:nvSpPr>
          <p:spPr>
            <a:xfrm>
              <a:off x="7688151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1 </a:t>
              </a:r>
              <a:endParaRPr lang="zh-CN" altLang="en-US" sz="1200" dirty="0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02D022A9-91F2-AA5B-4943-A08E02AB1856}"/>
                </a:ext>
              </a:extLst>
            </p:cNvPr>
            <p:cNvSpPr txBox="1"/>
            <p:nvPr/>
          </p:nvSpPr>
          <p:spPr>
            <a:xfrm>
              <a:off x="7940555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2 </a:t>
              </a:r>
              <a:endParaRPr lang="zh-CN" altLang="en-US" sz="1200" dirty="0"/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FB1B2195-187F-7A70-9A88-C7BD1E89A226}"/>
                </a:ext>
              </a:extLst>
            </p:cNvPr>
            <p:cNvSpPr txBox="1"/>
            <p:nvPr/>
          </p:nvSpPr>
          <p:spPr>
            <a:xfrm>
              <a:off x="8192959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3 </a:t>
              </a:r>
              <a:endParaRPr lang="zh-CN" altLang="en-US" sz="1200" dirty="0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2EA31422-D5EF-85B4-D707-437F377217BB}"/>
                </a:ext>
              </a:extLst>
            </p:cNvPr>
            <p:cNvSpPr txBox="1"/>
            <p:nvPr/>
          </p:nvSpPr>
          <p:spPr>
            <a:xfrm>
              <a:off x="8445368" y="1472206"/>
              <a:ext cx="3386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24</a:t>
              </a:r>
              <a:endParaRPr lang="zh-CN" altLang="en-US" sz="1200" dirty="0"/>
            </a:p>
          </p:txBody>
        </p:sp>
      </p:grpSp>
      <p:sp>
        <p:nvSpPr>
          <p:cNvPr id="57" name="文本框 56">
            <a:extLst>
              <a:ext uri="{FF2B5EF4-FFF2-40B4-BE49-F238E27FC236}">
                <a16:creationId xmlns:a16="http://schemas.microsoft.com/office/drawing/2014/main" id="{A4C951A2-EA43-82C7-B526-297CBA24ADEF}"/>
              </a:ext>
            </a:extLst>
          </p:cNvPr>
          <p:cNvSpPr txBox="1"/>
          <p:nvPr/>
        </p:nvSpPr>
        <p:spPr>
          <a:xfrm>
            <a:off x="2402895" y="5119794"/>
            <a:ext cx="81310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positive single-root plants. M: DL2000 Marker; 1-3: Blank control; 4-27: Positive single-root plant.</a:t>
            </a:r>
          </a:p>
        </p:txBody>
      </p:sp>
    </p:spTree>
    <p:extLst>
      <p:ext uri="{BB962C8B-B14F-4D97-AF65-F5344CB8AC3E}">
        <p14:creationId xmlns:p14="http://schemas.microsoft.com/office/powerpoint/2010/main" val="146462864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9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畅</dc:creator>
  <cp:lastModifiedBy>MDPI</cp:lastModifiedBy>
  <cp:revision>2</cp:revision>
  <dcterms:created xsi:type="dcterms:W3CDTF">2023-04-13T08:28:34Z</dcterms:created>
  <dcterms:modified xsi:type="dcterms:W3CDTF">2023-05-12T09:17:48Z</dcterms:modified>
</cp:coreProperties>
</file>